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7.xml.rels" ContentType="application/vnd.openxmlformats-package.relationships+xml"/>
  <Override PartName="/ppt/notesSlides/_rels/notesSlide1.xml.rels" ContentType="application/vnd.openxmlformats-package.relationships+xml"/>
  <Override PartName="/ppt/notesSlides/_rels/notesSlide6.xml.rels" ContentType="application/vnd.openxmlformats-package.relationships+xml"/>
  <Override PartName="/ppt/notesSlides/_rels/notesSlide5.xml.rels" ContentType="application/vnd.openxmlformats-package.relationships+xml"/>
  <Override PartName="/ppt/notesSlides/_rels/notesSlide4.xml.rels" ContentType="application/vnd.openxmlformats-package.relationships+xml"/>
  <Override PartName="/ppt/notesSlides/_rels/notesSlide3.xml.rels" ContentType="application/vnd.openxmlformats-package.relationships+xml"/>
  <Override PartName="/ppt/notesSlides/_rels/notesSlide2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</p:sldIdLst>
  <p:sldSz cx="12193588" cy="6858000"/>
  <p:notesSz cx="7559675" cy="10691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560000" cy="10692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sldImg"/>
          </p:nvPr>
        </p:nvSpPr>
        <p:spPr>
          <a:xfrm>
            <a:off x="215640" y="812880"/>
            <a:ext cx="7126200" cy="4006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>
              <a:lnSpc>
                <a:spcPct val="8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body"/>
          </p:nvPr>
        </p:nvSpPr>
        <p:spPr>
          <a:xfrm>
            <a:off x="755280" y="5078160"/>
            <a:ext cx="6046920" cy="4809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hdr"/>
          </p:nvPr>
        </p:nvSpPr>
        <p:spPr>
          <a:xfrm>
            <a:off x="0" y="0"/>
            <a:ext cx="3279600" cy="533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dt" idx="3"/>
          </p:nvPr>
        </p:nvSpPr>
        <p:spPr>
          <a:xfrm>
            <a:off x="4277880" y="0"/>
            <a:ext cx="3279960" cy="533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4"/>
          </p:nvPr>
        </p:nvSpPr>
        <p:spPr>
          <a:xfrm>
            <a:off x="0" y="10156680"/>
            <a:ext cx="3279600" cy="533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indent="0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5"/>
          </p:nvPr>
        </p:nvSpPr>
        <p:spPr>
          <a:xfrm>
            <a:off x="4277880" y="10156680"/>
            <a:ext cx="3279960" cy="533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lstStyle>
            <a:lvl1pPr indent="0" algn="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  <a:defRPr b="0" lang="de-DE" sz="1400" spc="-1" strike="noStrike">
                <a:solidFill>
                  <a:srgbClr val="000000"/>
                </a:solidFill>
                <a:latin typeface="Times New Roman"/>
                <a:ea typeface="DejaVu Sans"/>
              </a:defRPr>
            </a:lvl1pPr>
          </a:lstStyle>
          <a:p>
            <a:pPr indent="0" algn="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fld id="{0FB779B0-E71D-4F9B-AA50-9650C1845AB1}" type="slidenum">
              <a:rPr b="0" lang="de-DE" sz="1400" spc="-1" strike="noStrike">
                <a:solidFill>
                  <a:srgbClr val="000000"/>
                </a:solidFill>
                <a:latin typeface="Times New Roman"/>
                <a:ea typeface="DejaVu Sans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_rels/notesSlide4.xml.rels><?xml version="1.0" encoding="UTF-8"?>
<Relationships xmlns="http://schemas.openxmlformats.org/package/2006/relationships"><Relationship Id="rId1" Type="http://schemas.openxmlformats.org/officeDocument/2006/relationships/slide" Target="../slides/slide4.xml"/><Relationship Id="rId2" Type="http://schemas.openxmlformats.org/officeDocument/2006/relationships/notesMaster" Target="../notesMasters/notesMaster1.xml"/>
</Relationships>
</file>

<file path=ppt/notesSlides/_rels/notesSlide5.xml.rels><?xml version="1.0" encoding="UTF-8"?>
<Relationships xmlns="http://schemas.openxmlformats.org/package/2006/relationships"><Relationship Id="rId1" Type="http://schemas.openxmlformats.org/officeDocument/2006/relationships/slide" Target="../slides/slide5.xml"/><Relationship Id="rId2" Type="http://schemas.openxmlformats.org/officeDocument/2006/relationships/notesMaster" Target="../notesMasters/notesMaster1.xml"/>
</Relationships>
</file>

<file path=ppt/notesSlides/_rels/notesSlide6.xml.rels><?xml version="1.0" encoding="UTF-8"?>
<Relationships xmlns="http://schemas.openxmlformats.org/package/2006/relationships"><Relationship Id="rId1" Type="http://schemas.openxmlformats.org/officeDocument/2006/relationships/slide" Target="../slides/slide6.xml"/><Relationship Id="rId2" Type="http://schemas.openxmlformats.org/officeDocument/2006/relationships/notesMaster" Target="../notesMasters/notesMaster1.xml"/>
</Relationships>
</file>

<file path=ppt/notesSlides/_rels/notesSlide7.xml.rels><?xml version="1.0" encoding="UTF-8"?>
<Relationships xmlns="http://schemas.openxmlformats.org/package/2006/relationships"><Relationship Id="rId1" Type="http://schemas.openxmlformats.org/officeDocument/2006/relationships/slide" Target="../slides/slide7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Rectangle 6"/>
          <p:cNvSpPr/>
          <p:nvPr/>
        </p:nvSpPr>
        <p:spPr>
          <a:xfrm>
            <a:off x="4278240" y="10156680"/>
            <a:ext cx="3279960" cy="533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b">
            <a:noAutofit/>
          </a:bodyPr>
          <a:p>
            <a:pPr algn="r"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fld id="{DCB79384-41F1-4891-BFC5-EF4B40D8F839}" type="slidenum">
              <a:rPr b="0" lang="de-DE" sz="1400" spc="-1" strike="noStrike">
                <a:solidFill>
                  <a:srgbClr val="000000"/>
                </a:solidFill>
                <a:latin typeface="Times New Roman"/>
                <a:ea typeface="DejaVu Sans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PlaceHolder 1"/>
          <p:cNvSpPr>
            <a:spLocks noGrp="1"/>
          </p:cNvSpPr>
          <p:nvPr>
            <p:ph type="sldImg"/>
          </p:nvPr>
        </p:nvSpPr>
        <p:spPr>
          <a:xfrm>
            <a:off x="217440" y="812880"/>
            <a:ext cx="7124760" cy="4008240"/>
          </a:xfrm>
          <a:prstGeom prst="rect">
            <a:avLst/>
          </a:prstGeom>
          <a:ln w="0">
            <a:noFill/>
          </a:ln>
        </p:spPr>
      </p:sp>
      <p:sp>
        <p:nvSpPr>
          <p:cNvPr id="64" name="PlaceHolder 2"/>
          <p:cNvSpPr>
            <a:spLocks noGrp="1"/>
          </p:cNvSpPr>
          <p:nvPr>
            <p:ph type="body"/>
          </p:nvPr>
        </p:nvSpPr>
        <p:spPr>
          <a:xfrm>
            <a:off x="755280" y="5078520"/>
            <a:ext cx="6048360" cy="4811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Rectangle 6"/>
          <p:cNvSpPr/>
          <p:nvPr/>
        </p:nvSpPr>
        <p:spPr>
          <a:xfrm>
            <a:off x="4278240" y="10156680"/>
            <a:ext cx="3279960" cy="533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b">
            <a:noAutofit/>
          </a:bodyPr>
          <a:p>
            <a:pPr algn="r"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fld id="{7DB8BE6F-DF71-445C-A284-61DCF8461801}" type="slidenum">
              <a:rPr b="0" lang="de-DE" sz="1400" spc="-1" strike="noStrike">
                <a:solidFill>
                  <a:srgbClr val="000000"/>
                </a:solidFill>
                <a:latin typeface="Times New Roman"/>
                <a:ea typeface="DejaVu Sans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PlaceHolder 1"/>
          <p:cNvSpPr>
            <a:spLocks noGrp="1"/>
          </p:cNvSpPr>
          <p:nvPr>
            <p:ph type="sldImg"/>
          </p:nvPr>
        </p:nvSpPr>
        <p:spPr>
          <a:xfrm>
            <a:off x="217440" y="812880"/>
            <a:ext cx="7124760" cy="4008240"/>
          </a:xfrm>
          <a:prstGeom prst="rect">
            <a:avLst/>
          </a:prstGeom>
          <a:ln w="0">
            <a:noFill/>
          </a:ln>
        </p:spPr>
      </p:sp>
      <p:sp>
        <p:nvSpPr>
          <p:cNvPr id="67" name="PlaceHolder 2"/>
          <p:cNvSpPr>
            <a:spLocks noGrp="1"/>
          </p:cNvSpPr>
          <p:nvPr>
            <p:ph type="body"/>
          </p:nvPr>
        </p:nvSpPr>
        <p:spPr>
          <a:xfrm>
            <a:off x="755280" y="5078520"/>
            <a:ext cx="6048360" cy="4811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Rectangle 6"/>
          <p:cNvSpPr/>
          <p:nvPr/>
        </p:nvSpPr>
        <p:spPr>
          <a:xfrm>
            <a:off x="4278240" y="10156680"/>
            <a:ext cx="3279960" cy="533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b">
            <a:noAutofit/>
          </a:bodyPr>
          <a:p>
            <a:pPr algn="r"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fld id="{9FF238C7-E441-4CD1-BFC7-DF68F165A26E}" type="slidenum">
              <a:rPr b="0" lang="de-DE" sz="1400" spc="-1" strike="noStrike">
                <a:solidFill>
                  <a:srgbClr val="000000"/>
                </a:solidFill>
                <a:latin typeface="Times New Roman"/>
                <a:ea typeface="DejaVu Sans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PlaceHolder 1"/>
          <p:cNvSpPr>
            <a:spLocks noGrp="1"/>
          </p:cNvSpPr>
          <p:nvPr>
            <p:ph type="sldImg"/>
          </p:nvPr>
        </p:nvSpPr>
        <p:spPr>
          <a:xfrm>
            <a:off x="217440" y="812880"/>
            <a:ext cx="7124760" cy="4008240"/>
          </a:xfrm>
          <a:prstGeom prst="rect">
            <a:avLst/>
          </a:prstGeom>
          <a:ln w="0">
            <a:noFill/>
          </a:ln>
        </p:spPr>
      </p:sp>
      <p:sp>
        <p:nvSpPr>
          <p:cNvPr id="70" name="PlaceHolder 2"/>
          <p:cNvSpPr>
            <a:spLocks noGrp="1"/>
          </p:cNvSpPr>
          <p:nvPr>
            <p:ph type="body"/>
          </p:nvPr>
        </p:nvSpPr>
        <p:spPr>
          <a:xfrm>
            <a:off x="755280" y="5078520"/>
            <a:ext cx="6048360" cy="4811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notes>
</file>

<file path=ppt/notesSlides/notesSlide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Rectangle 6"/>
          <p:cNvSpPr/>
          <p:nvPr/>
        </p:nvSpPr>
        <p:spPr>
          <a:xfrm>
            <a:off x="4278240" y="10156680"/>
            <a:ext cx="3279960" cy="533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b">
            <a:noAutofit/>
          </a:bodyPr>
          <a:p>
            <a:pPr algn="r"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fld id="{B136B5F5-C437-4974-8E49-0D04AB65DBD9}" type="slidenum">
              <a:rPr b="0" lang="de-DE" sz="1400" spc="-1" strike="noStrike">
                <a:solidFill>
                  <a:srgbClr val="000000"/>
                </a:solidFill>
                <a:latin typeface="Times New Roman"/>
                <a:ea typeface="DejaVu Sans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PlaceHolder 1"/>
          <p:cNvSpPr>
            <a:spLocks noGrp="1"/>
          </p:cNvSpPr>
          <p:nvPr>
            <p:ph type="sldImg"/>
          </p:nvPr>
        </p:nvSpPr>
        <p:spPr>
          <a:xfrm>
            <a:off x="217440" y="812880"/>
            <a:ext cx="7124760" cy="4008240"/>
          </a:xfrm>
          <a:prstGeom prst="rect">
            <a:avLst/>
          </a:prstGeom>
          <a:ln w="0">
            <a:noFill/>
          </a:ln>
        </p:spPr>
      </p:sp>
      <p:sp>
        <p:nvSpPr>
          <p:cNvPr id="73" name="PlaceHolder 2"/>
          <p:cNvSpPr>
            <a:spLocks noGrp="1"/>
          </p:cNvSpPr>
          <p:nvPr>
            <p:ph type="body"/>
          </p:nvPr>
        </p:nvSpPr>
        <p:spPr>
          <a:xfrm>
            <a:off x="755280" y="5078520"/>
            <a:ext cx="6048360" cy="4811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notes>
</file>

<file path=ppt/notesSlides/notesSlide5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" name="Rectangle 6"/>
          <p:cNvSpPr/>
          <p:nvPr/>
        </p:nvSpPr>
        <p:spPr>
          <a:xfrm>
            <a:off x="4278240" y="10156680"/>
            <a:ext cx="3279960" cy="533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b">
            <a:noAutofit/>
          </a:bodyPr>
          <a:p>
            <a:pPr algn="r"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fld id="{CEC3A855-3D23-4165-A341-25628FCF0A46}" type="slidenum">
              <a:rPr b="0" lang="de-DE" sz="1400" spc="-1" strike="noStrike">
                <a:solidFill>
                  <a:srgbClr val="000000"/>
                </a:solidFill>
                <a:latin typeface="Times New Roman"/>
                <a:ea typeface="DejaVu Sans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PlaceHolder 1"/>
          <p:cNvSpPr>
            <a:spLocks noGrp="1"/>
          </p:cNvSpPr>
          <p:nvPr>
            <p:ph type="sldImg"/>
          </p:nvPr>
        </p:nvSpPr>
        <p:spPr>
          <a:xfrm>
            <a:off x="217440" y="812880"/>
            <a:ext cx="7124760" cy="4008240"/>
          </a:xfrm>
          <a:prstGeom prst="rect">
            <a:avLst/>
          </a:prstGeom>
          <a:ln w="0">
            <a:noFill/>
          </a:ln>
        </p:spPr>
      </p:sp>
      <p:sp>
        <p:nvSpPr>
          <p:cNvPr id="76" name="PlaceHolder 2"/>
          <p:cNvSpPr>
            <a:spLocks noGrp="1"/>
          </p:cNvSpPr>
          <p:nvPr>
            <p:ph type="body"/>
          </p:nvPr>
        </p:nvSpPr>
        <p:spPr>
          <a:xfrm>
            <a:off x="755280" y="5078520"/>
            <a:ext cx="6048360" cy="4811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notes>
</file>

<file path=ppt/notesSlides/notesSlide6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" name="Rectangle 6"/>
          <p:cNvSpPr/>
          <p:nvPr/>
        </p:nvSpPr>
        <p:spPr>
          <a:xfrm>
            <a:off x="4278240" y="10156680"/>
            <a:ext cx="3279960" cy="533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b">
            <a:noAutofit/>
          </a:bodyPr>
          <a:p>
            <a:pPr algn="r"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fld id="{DA1E00D1-8767-4EF0-A317-ACF274A21E50}" type="slidenum">
              <a:rPr b="0" lang="de-DE" sz="1400" spc="-1" strike="noStrike">
                <a:solidFill>
                  <a:srgbClr val="000000"/>
                </a:solidFill>
                <a:latin typeface="Times New Roman"/>
                <a:ea typeface="DejaVu Sans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PlaceHolder 1"/>
          <p:cNvSpPr>
            <a:spLocks noGrp="1"/>
          </p:cNvSpPr>
          <p:nvPr>
            <p:ph type="sldImg"/>
          </p:nvPr>
        </p:nvSpPr>
        <p:spPr>
          <a:xfrm>
            <a:off x="217440" y="812880"/>
            <a:ext cx="7124760" cy="4008240"/>
          </a:xfrm>
          <a:prstGeom prst="rect">
            <a:avLst/>
          </a:prstGeom>
          <a:ln w="0">
            <a:noFill/>
          </a:ln>
        </p:spPr>
      </p:sp>
      <p:sp>
        <p:nvSpPr>
          <p:cNvPr id="79" name="PlaceHolder 2"/>
          <p:cNvSpPr>
            <a:spLocks noGrp="1"/>
          </p:cNvSpPr>
          <p:nvPr>
            <p:ph type="body"/>
          </p:nvPr>
        </p:nvSpPr>
        <p:spPr>
          <a:xfrm>
            <a:off x="755280" y="5078520"/>
            <a:ext cx="6048360" cy="4811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notes>
</file>

<file path=ppt/notesSlides/notesSlide7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" name="Rectangle 6"/>
          <p:cNvSpPr/>
          <p:nvPr/>
        </p:nvSpPr>
        <p:spPr>
          <a:xfrm>
            <a:off x="4278240" y="10156680"/>
            <a:ext cx="3279960" cy="533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b">
            <a:noAutofit/>
          </a:bodyPr>
          <a:p>
            <a:pPr algn="r"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fld id="{FC2EF19B-8FE9-412F-B677-605EE950BE3C}" type="slidenum">
              <a:rPr b="0" lang="de-DE" sz="1400" spc="-1" strike="noStrike">
                <a:solidFill>
                  <a:srgbClr val="000000"/>
                </a:solidFill>
                <a:latin typeface="Times New Roman"/>
                <a:ea typeface="DejaVu Sans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PlaceHolder 1"/>
          <p:cNvSpPr>
            <a:spLocks noGrp="1"/>
          </p:cNvSpPr>
          <p:nvPr>
            <p:ph type="sldImg"/>
          </p:nvPr>
        </p:nvSpPr>
        <p:spPr>
          <a:xfrm>
            <a:off x="217440" y="812880"/>
            <a:ext cx="7124760" cy="4008240"/>
          </a:xfrm>
          <a:prstGeom prst="rect">
            <a:avLst/>
          </a:prstGeom>
          <a:ln w="0">
            <a:noFill/>
          </a:ln>
        </p:spPr>
      </p:sp>
      <p:sp>
        <p:nvSpPr>
          <p:cNvPr id="82" name="PlaceHolder 2"/>
          <p:cNvSpPr>
            <a:spLocks noGrp="1"/>
          </p:cNvSpPr>
          <p:nvPr>
            <p:ph type="body"/>
          </p:nvPr>
        </p:nvSpPr>
        <p:spPr>
          <a:xfrm>
            <a:off x="755280" y="5078520"/>
            <a:ext cx="6048360" cy="4811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381500E4-6ABE-4965-A936-5BC8C946F7E6}" type="slidenum">
              <a:t>&lt;#&gt;</a:t>
            </a:fld>
          </a:p>
        </p:txBody>
      </p:sp>
      <p:sp>
        <p:nvSpPr>
          <p:cNvPr id="3" name="PlaceHolder 2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4160" cy="1324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8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4160" cy="207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75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7520"/>
            <a:ext cx="10514160" cy="207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75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986C7289-7535-4646-9EE4-32CEF6FC4D7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4160" cy="1324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8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0720" cy="207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75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5840" y="1825200"/>
            <a:ext cx="5130720" cy="207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75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7520"/>
            <a:ext cx="5130720" cy="207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75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5840" y="4097520"/>
            <a:ext cx="5130720" cy="207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75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525C13AB-A452-454D-B844-F852FF86DF9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4160" cy="1324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8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440" cy="207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75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080" y="1825200"/>
            <a:ext cx="3385440" cy="207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75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8440" y="1825200"/>
            <a:ext cx="3385440" cy="207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75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7520"/>
            <a:ext cx="3385440" cy="207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75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080" y="4097520"/>
            <a:ext cx="3385440" cy="207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75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8440" y="4097520"/>
            <a:ext cx="3385440" cy="207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75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56A06D6B-7826-417A-A809-89F35691BF0D}" type="slidenum">
              <a:t>&lt;#&gt;</a:t>
            </a:fld>
          </a:p>
        </p:txBody>
      </p:sp>
      <p:sp>
        <p:nvSpPr>
          <p:cNvPr id="10" name="PlaceHolder 9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4160" cy="1324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8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4160" cy="4349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75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C6CD5F76-8F8D-4519-9288-B7376EF4361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4160" cy="1324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8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4160" cy="434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75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4EF4C92F-C92C-462B-9BFC-7CE8E56C384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4160" cy="1324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8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0720" cy="434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75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5840" y="1825200"/>
            <a:ext cx="5130720" cy="434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75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037900D6-0B36-4749-8F6D-FDD97ECADFD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4160" cy="1324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8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B9C92028-F0DA-4C08-8EB3-9F28A0D12A7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4160" cy="6139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75000"/>
              </a:lnSpc>
              <a:spcBef>
                <a:spcPts val="1426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59D77E08-A08B-4597-A1F2-D39D87EE018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4160" cy="1324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8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0720" cy="207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75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5840" y="1825200"/>
            <a:ext cx="5130720" cy="434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75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7520"/>
            <a:ext cx="5130720" cy="207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75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C5FD2798-3983-4489-AF7C-9B1397A4EAF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4160" cy="1324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8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0720" cy="434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75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5840" y="1825200"/>
            <a:ext cx="5130720" cy="207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75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5840" y="4097520"/>
            <a:ext cx="5130720" cy="207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75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D0A4A896-B095-4DAC-BD70-A427990D957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4160" cy="1324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8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0720" cy="207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75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5840" y="1825200"/>
            <a:ext cx="5130720" cy="207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75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7520"/>
            <a:ext cx="10514160" cy="207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75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86C12E2B-EC0A-47D9-8E35-980FC9E6E29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4160" cy="1324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8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4160" cy="434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75000"/>
              </a:lnSpc>
              <a:spcBef>
                <a:spcPts val="1426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343080" indent="-343080">
              <a:lnSpc>
                <a:spcPct val="75000"/>
              </a:lnSpc>
              <a:spcBef>
                <a:spcPts val="1426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343080" indent="-343080">
              <a:lnSpc>
                <a:spcPct val="75000"/>
              </a:lnSpc>
              <a:spcBef>
                <a:spcPts val="1426"/>
              </a:spcBef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343080" indent="-343080">
              <a:lnSpc>
                <a:spcPct val="75000"/>
              </a:lnSpc>
              <a:spcBef>
                <a:spcPts val="1426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343080" indent="-343080">
              <a:lnSpc>
                <a:spcPct val="75000"/>
              </a:lnSpc>
              <a:spcBef>
                <a:spcPts val="1426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343080" indent="-343080">
              <a:lnSpc>
                <a:spcPct val="75000"/>
              </a:lnSpc>
              <a:spcBef>
                <a:spcPts val="1426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343080" indent="-343080">
              <a:lnSpc>
                <a:spcPct val="75000"/>
              </a:lnSpc>
              <a:spcBef>
                <a:spcPts val="1426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160"/>
            <a:ext cx="2741760" cy="363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  <a:defRPr b="0" lang="de-DE" sz="1200" spc="-1" strike="noStrike">
                <a:solidFill>
                  <a:srgbClr val="8b8b8b"/>
                </a:solidFill>
                <a:latin typeface="Calibri"/>
                <a:ea typeface="DejaVu Sans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de-DE" sz="1200" spc="-1" strike="noStrike">
                <a:solidFill>
                  <a:srgbClr val="8b8b8b"/>
                </a:solidFill>
                <a:latin typeface="Calibri"/>
                <a:ea typeface="DejaVu Sans"/>
              </a:rPr>
              <a:t>26.03.2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Text Box 4"/>
          <p:cNvSpPr/>
          <p:nvPr/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4"/>
          <p:cNvSpPr>
            <a:spLocks noGrp="1"/>
          </p:cNvSpPr>
          <p:nvPr>
            <p:ph type="sldNum" idx="2"/>
          </p:nvPr>
        </p:nvSpPr>
        <p:spPr>
          <a:xfrm>
            <a:off x="8610480" y="6356160"/>
            <a:ext cx="2741760" cy="363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  <a:defRPr b="0" lang="de-DE" sz="1200" spc="-1" strike="noStrike">
                <a:solidFill>
                  <a:srgbClr val="8b8b8b"/>
                </a:solidFill>
                <a:latin typeface="Calibri"/>
                <a:ea typeface="DejaVu Sans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fld id="{77CD84A0-F121-41C0-998C-DD3C2AB9E049}" type="slidenum">
              <a:rPr b="0" lang="de-DE" sz="1200" spc="-1" strike="noStrike">
                <a:solidFill>
                  <a:srgbClr val="8b8b8b"/>
                </a:solidFill>
                <a:latin typeface="Calibri"/>
                <a:ea typeface="DejaVu Sans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4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5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6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7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ctangle 1"/>
          <p:cNvSpPr/>
          <p:nvPr/>
        </p:nvSpPr>
        <p:spPr>
          <a:xfrm>
            <a:off x="1390680" y="5578560"/>
            <a:ext cx="9248760" cy="25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Calibri"/>
              </a:rPr>
              <a:t>Supplementary Figure 1: Screenshot of the interactive teaching tool for the subject zoology. A German version was used in the evaluation study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" name="Picture 2" descr=""/>
          <p:cNvPicPr/>
          <p:nvPr/>
        </p:nvPicPr>
        <p:blipFill>
          <a:blip r:embed="rId1"/>
          <a:stretch/>
        </p:blipFill>
        <p:spPr>
          <a:xfrm>
            <a:off x="1308240" y="1160640"/>
            <a:ext cx="8286480" cy="4300200"/>
          </a:xfrm>
          <a:prstGeom prst="rect">
            <a:avLst/>
          </a:prstGeom>
          <a:ln w="0">
            <a:noFill/>
          </a:ln>
        </p:spPr>
      </p:pic>
    </p:spTree>
  </p:cSld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Rectangle 1"/>
          <p:cNvSpPr/>
          <p:nvPr/>
        </p:nvSpPr>
        <p:spPr>
          <a:xfrm>
            <a:off x="1390680" y="5578560"/>
            <a:ext cx="9248760" cy="25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Calibri"/>
              </a:rPr>
              <a:t>Supplementary Figure 2: Screenshot of the interactive teaching tool for the subject food science. A German version was used in the evaluation study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1" name="Picture 2" descr=""/>
          <p:cNvPicPr/>
          <p:nvPr/>
        </p:nvPicPr>
        <p:blipFill>
          <a:blip r:embed="rId1"/>
          <a:stretch/>
        </p:blipFill>
        <p:spPr>
          <a:xfrm>
            <a:off x="1486080" y="861840"/>
            <a:ext cx="7283160" cy="4621320"/>
          </a:xfrm>
          <a:prstGeom prst="rect">
            <a:avLst/>
          </a:prstGeom>
          <a:ln w="0">
            <a:noFill/>
          </a:ln>
        </p:spPr>
      </p:pic>
    </p:spTree>
  </p:cSld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2" name=""/>
          <p:cNvGraphicFramePr/>
          <p:nvPr/>
        </p:nvGraphicFramePr>
        <p:xfrm>
          <a:off x="2068560" y="2138400"/>
          <a:ext cx="8297640" cy="2583000"/>
        </p:xfrm>
        <a:graphic>
          <a:graphicData uri="http://schemas.openxmlformats.org/drawingml/2006/table">
            <a:tbl>
              <a:tblPr/>
              <a:tblGrid>
                <a:gridCol w="3905280"/>
                <a:gridCol w="1081080"/>
                <a:gridCol w="676080"/>
                <a:gridCol w="878040"/>
                <a:gridCol w="878040"/>
                <a:gridCol w="879120"/>
              </a:tblGrid>
              <a:tr h="1904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1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Questio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1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trongly disagre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1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disagre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1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eutral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1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gre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1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trongly agre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80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B1: I can imagine that the majority of students will handle easily interactive graphic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 (1.1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 (1.1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 (7.9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6 (40.4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4 (49.3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080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B2: I wish to have more interactive graphics in veterinary  school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( 1.1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 (1.1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2 (13.5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4 (38.2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0 (44.9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04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B3: I can image using this tool because it´s intuitiv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 (2.2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 (1.1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4 (15.7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7 (41.6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5 (39.3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04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4: I was previously familiar with the taught conten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0 (33.7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6 (29.2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0 (22.5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 (7.9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 (6.7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80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5: I understood the teaching contents taught by the </a:t>
                      </a:r>
                      <a:br>
                        <a:rPr sz="1100"/>
                      </a:b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interactive graphi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 (2.2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 (1.1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 (11.2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3 (37.1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3 (48.3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366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6: The interactivity of this graphic had a positive impact on my interest about the taught conten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 (4.5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 (4.5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7 (19.1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1 (34.8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3 (37.1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120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7: The interactive graphic had no benefit to the cours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2 (40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8 (30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1 (10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 (10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 (10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812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D9: Digitalization is a chance to improve higher school </a:t>
                      </a:r>
                      <a:br>
                        <a:rPr sz="1100"/>
                      </a:b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ducatio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 (0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 (1.1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 (7.9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7 (41.6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4 (49.4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53" name="Rectangle 179"/>
          <p:cNvSpPr/>
          <p:nvPr/>
        </p:nvSpPr>
        <p:spPr>
          <a:xfrm>
            <a:off x="1969920" y="4900680"/>
            <a:ext cx="8175960" cy="425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Calibri"/>
              </a:rPr>
              <a:t>S.T1: Absolute and relative distributions of response (grade of agreement: 1 – 5, ranging from strongly disagree to strongly agree) for Likert-Scale questions asked in the zoology course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Rectangle 1"/>
          <p:cNvSpPr/>
          <p:nvPr/>
        </p:nvSpPr>
        <p:spPr>
          <a:xfrm>
            <a:off x="1995480" y="4924440"/>
            <a:ext cx="8845560" cy="45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Calibri"/>
              </a:rPr>
              <a:t>S.T2: Absolute and relative distributions of response (grade of agreement: 1 – 5, ranging from strongly disagree to strongly agree) for Likert-Scale questions asked in the animal nutrition course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5" name=""/>
          <p:cNvGraphicFramePr/>
          <p:nvPr/>
        </p:nvGraphicFramePr>
        <p:xfrm>
          <a:off x="2100240" y="2171880"/>
          <a:ext cx="8502840" cy="2433600"/>
        </p:xfrm>
        <a:graphic>
          <a:graphicData uri="http://schemas.openxmlformats.org/drawingml/2006/table">
            <a:tbl>
              <a:tblPr/>
              <a:tblGrid>
                <a:gridCol w="3645000"/>
                <a:gridCol w="404640"/>
                <a:gridCol w="1121040"/>
                <a:gridCol w="761760"/>
                <a:gridCol w="762120"/>
                <a:gridCol w="762120"/>
                <a:gridCol w="1046160"/>
              </a:tblGrid>
              <a:tr h="1774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1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Questio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1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1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trongly disagre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1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disagre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1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eutral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1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gre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1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trongly agre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445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B1: I can imagine that the mayoritiy of students  will handle easily interactive graphic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1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 (0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 (3.3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1 (14.4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3 (43.3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3 (38.6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445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B2: I wish to have more interactive graphics in veterinary  school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1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 (1.9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5 (7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9 (18.1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7 (45.1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0 (27.9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78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B3: I can image using this tool because it´s intuitiv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1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 (2.3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5 (7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5 (16.3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3 (43.3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7 (31.2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78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4: I was previously familiar with the taught conten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1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0 (37.2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3 (24.7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0 (27.9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8 (8.4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 (1.4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445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5: I understood the teaching contents taught by the </a:t>
                      </a:r>
                      <a:br>
                        <a:rPr sz="1100"/>
                      </a:b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interactive graphi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1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 (1.4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4 (6.5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9 (13.5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4 (39.1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4 (39.1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445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6: The interactivity of the graphic had a positive impact on my interest about the taught conten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1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 (3.3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7 (7.9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3 (20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7 (40.5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0 (27.9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78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7: The interactive graphic had no benefit to the cours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1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0 (37.6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5 (30.5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9 (13.6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8 (13.1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1 (5.2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445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D9: Digitalization is a chance to improve higher school </a:t>
                      </a:r>
                      <a:br>
                        <a:rPr sz="1100"/>
                      </a:b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ducatio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1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 (0.5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 (2.8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9 (13.5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8 (31.6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11 (51.6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Rectangle 1"/>
          <p:cNvSpPr/>
          <p:nvPr/>
        </p:nvSpPr>
        <p:spPr>
          <a:xfrm>
            <a:off x="1901880" y="4832280"/>
            <a:ext cx="8416800" cy="45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Calibri"/>
              </a:rPr>
              <a:t>S.T3: Absolute and relative distributions of response (grade of agreement: 1 – 5, ranging from strongly disagree to strongly agree) for Likert-Scale questions asked in the food science course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7" name=""/>
          <p:cNvGraphicFramePr/>
          <p:nvPr/>
        </p:nvGraphicFramePr>
        <p:xfrm>
          <a:off x="2013120" y="2146320"/>
          <a:ext cx="8167680" cy="2563920"/>
        </p:xfrm>
        <a:graphic>
          <a:graphicData uri="http://schemas.openxmlformats.org/drawingml/2006/table">
            <a:tbl>
              <a:tblPr/>
              <a:tblGrid>
                <a:gridCol w="3962160"/>
                <a:gridCol w="1052640"/>
                <a:gridCol w="638280"/>
                <a:gridCol w="761760"/>
                <a:gridCol w="762120"/>
                <a:gridCol w="990720"/>
              </a:tblGrid>
              <a:tr h="2779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1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Questio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1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trongly disagre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1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disagre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1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eutral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1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gre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1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trongly agre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80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B1: I can imagine that the mayoritiy of students  will handle easily interactive graphic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 (0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 (0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 (0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 (26.1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7 (73.9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04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B2: I wish to have more interactive graphics in veterinary  school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 (0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 (0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 (21.7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 (39.1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 (39.1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04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B3: I can image using this tool because it´s intuitiv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 (0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(0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 (4.3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 (43.5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2 (52.2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04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4: I was previously familiar with the taught conten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7 (73.9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 (17.4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 (4.3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 (0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 (4.3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812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5: I understood the teaching contents taught by the </a:t>
                      </a:r>
                      <a:br>
                        <a:rPr sz="1100"/>
                      </a:b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interactive graphi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 (0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 (0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 (0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 (17.4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9 (82.6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80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6: The interactivity of theís graphic had a positive</a:t>
                      </a:r>
                      <a:br>
                        <a:rPr sz="1100"/>
                      </a:b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impact on my interest about the taught conten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 (0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 (0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 (4.3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1 (47.8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1 (47.8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04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7: The interactive graphic had no benefit to the cours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9 (82.6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 (17.4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(0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 (0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(0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812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D9: Digitalization is a chance to improve higher school </a:t>
                      </a:r>
                      <a:br>
                        <a:rPr sz="1100"/>
                      </a:b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ducatio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 (0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 (0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 (13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 (43.5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 (43.5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8" name=""/>
          <p:cNvGraphicFramePr/>
          <p:nvPr/>
        </p:nvGraphicFramePr>
        <p:xfrm>
          <a:off x="3398760" y="2057400"/>
          <a:ext cx="6199200" cy="1908000"/>
        </p:xfrm>
        <a:graphic>
          <a:graphicData uri="http://schemas.openxmlformats.org/drawingml/2006/table">
            <a:tbl>
              <a:tblPr/>
              <a:tblGrid>
                <a:gridCol w="581040"/>
                <a:gridCol w="351000"/>
                <a:gridCol w="352440"/>
                <a:gridCol w="352440"/>
                <a:gridCol w="350640"/>
                <a:gridCol w="351000"/>
                <a:gridCol w="350640"/>
                <a:gridCol w="351000"/>
                <a:gridCol w="352440"/>
                <a:gridCol w="350640"/>
                <a:gridCol w="351000"/>
                <a:gridCol w="350640"/>
                <a:gridCol w="351000"/>
                <a:gridCol w="351000"/>
                <a:gridCol w="350640"/>
                <a:gridCol w="351000"/>
                <a:gridCol w="350640"/>
              </a:tblGrid>
              <a:tr h="141840">
                <a:tc>
                  <a:txBody>
                    <a:bodyPr lIns="68400" rIns="6840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2"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1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B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1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B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1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B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1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C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1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C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1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C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1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C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1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D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496440">
                <a:tc>
                  <a:txBody>
                    <a:bodyPr lIns="68400" rIns="68400" tIns="0" bIns="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1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No Medi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40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1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usag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y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y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y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y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y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y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y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y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840">
                <a:tc>
                  <a:txBody>
                    <a:bodyPr lIns="68400" rIns="6840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4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4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840">
                <a:tc>
                  <a:txBody>
                    <a:bodyPr lIns="68400" rIns="6840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5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840">
                <a:tc>
                  <a:txBody>
                    <a:bodyPr lIns="68400" rIns="6840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840">
                <a:tc>
                  <a:txBody>
                    <a:bodyPr lIns="68400" rIns="6840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4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5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4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4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4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4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840">
                <a:tc>
                  <a:txBody>
                    <a:bodyPr lIns="68400" rIns="6840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4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4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5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7560">
                <a:tc>
                  <a:txBody>
                    <a:bodyPr lIns="68400" rIns="68400" tIns="0" bIns="0" anchor="t">
                      <a:noAutofit/>
                    </a:bodyPr>
                    <a:p>
                      <a:pPr algn="just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18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3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18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3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18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3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18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3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18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3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18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3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18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3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18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3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840">
                <a:tc>
                  <a:txBody>
                    <a:bodyPr lIns="68400" rIns="6840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1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p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2"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.0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.1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.2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.8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.7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.1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.0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&lt; 0.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1280">
                <a:tc>
                  <a:txBody>
                    <a:bodyPr lIns="68400" rIns="6840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1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p</a:t>
                      </a:r>
                      <a:r>
                        <a:rPr b="1" lang="de-DE" sz="1000" spc="-1" strike="noStrike" baseline="-25000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Hol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2"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.2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.5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.8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.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.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.5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.1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.0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</a:tbl>
          </a:graphicData>
        </a:graphic>
      </p:graphicFrame>
      <p:sp>
        <p:nvSpPr>
          <p:cNvPr id="59" name="Rectangle 467"/>
          <p:cNvSpPr/>
          <p:nvPr/>
        </p:nvSpPr>
        <p:spPr>
          <a:xfrm>
            <a:off x="3281400" y="4960800"/>
            <a:ext cx="6329160" cy="637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Calibri"/>
              </a:rPr>
              <a:t>S.T4: Percentage distributions of response (grade of agreement: 1 – 5, ranging from strongly disagree to strongly agree) for Likert-Scale questions asked in the animal nutrition course, separately for those who use other digital learning media or not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0" name=""/>
          <p:cNvGraphicFramePr/>
          <p:nvPr/>
        </p:nvGraphicFramePr>
        <p:xfrm>
          <a:off x="3398760" y="2057400"/>
          <a:ext cx="5394240" cy="1844640"/>
        </p:xfrm>
        <a:graphic>
          <a:graphicData uri="http://schemas.openxmlformats.org/drawingml/2006/table">
            <a:tbl>
              <a:tblPr/>
              <a:tblGrid>
                <a:gridCol w="482760"/>
                <a:gridCol w="288720"/>
                <a:gridCol w="289080"/>
                <a:gridCol w="288720"/>
                <a:gridCol w="290520"/>
                <a:gridCol w="290520"/>
                <a:gridCol w="290520"/>
                <a:gridCol w="290520"/>
                <a:gridCol w="358920"/>
                <a:gridCol w="290520"/>
                <a:gridCol w="357120"/>
                <a:gridCol w="290520"/>
                <a:gridCol w="290520"/>
                <a:gridCol w="290520"/>
                <a:gridCol w="357120"/>
                <a:gridCol w="290520"/>
                <a:gridCol w="357120"/>
              </a:tblGrid>
              <a:tr h="141840">
                <a:tc>
                  <a:txBody>
                    <a:bodyPr lIns="68400" rIns="6840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2">
                  <a:txBody>
                    <a:bodyPr lIns="68400" rIns="6840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1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B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68400" rIns="6840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1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B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68400" rIns="6840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1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B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68400" rIns="6840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1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C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68400" rIns="6840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1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C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68400" rIns="6840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1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C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68400" rIns="6840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1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C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68400" rIns="6840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1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D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568080">
                <a:tc>
                  <a:txBody>
                    <a:bodyPr lIns="68400" rIns="6840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No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just">
                        <a:lnSpc>
                          <a:spcPct val="140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media usag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y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y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y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y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y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y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y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y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840">
                <a:tc>
                  <a:txBody>
                    <a:bodyPr lIns="68400" rIns="6840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7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8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840">
                <a:tc>
                  <a:txBody>
                    <a:bodyPr lIns="68400" rIns="6840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840">
                <a:tc>
                  <a:txBody>
                    <a:bodyPr lIns="68400" rIns="6840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840">
                <a:tc>
                  <a:txBody>
                    <a:bodyPr lIns="68400" rIns="6840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6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4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5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5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840">
                <a:tc>
                  <a:txBody>
                    <a:bodyPr lIns="68400" rIns="6840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7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6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4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5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6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8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4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6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5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840">
                <a:tc>
                  <a:txBody>
                    <a:bodyPr lIns="68400" rIns="68400" tIns="0" bIns="0" anchor="t">
                      <a:noAutofit/>
                    </a:bodyPr>
                    <a:p>
                      <a:pPr algn="just">
                        <a:lnSpc>
                          <a:spcPct val="8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1" lang="de-DE" sz="11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840">
                <a:tc>
                  <a:txBody>
                    <a:bodyPr lIns="68400" rIns="6840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1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p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2"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.8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.2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.6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.3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.4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.5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.4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&lt; 0.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1280">
                <a:tc>
                  <a:txBody>
                    <a:bodyPr lIns="68400" rIns="6840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1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p</a:t>
                      </a:r>
                      <a:r>
                        <a:rPr b="1" lang="de-DE" sz="1000" spc="-1" strike="noStrike" baseline="-25000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Hol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2"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.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.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.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.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.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.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.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68400" rIns="68400" tIns="0" bIns="0" anchor="t">
                      <a:noAutofit/>
                    </a:bodyPr>
                    <a:p>
                      <a:pPr algn="r">
                        <a:lnSpc>
                          <a:spcPct val="93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.0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</a:tbl>
          </a:graphicData>
        </a:graphic>
      </p:graphicFrame>
      <p:sp>
        <p:nvSpPr>
          <p:cNvPr id="61" name="Rectangle 467"/>
          <p:cNvSpPr/>
          <p:nvPr/>
        </p:nvSpPr>
        <p:spPr>
          <a:xfrm>
            <a:off x="3112920" y="4902120"/>
            <a:ext cx="6096240" cy="637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Calibri"/>
              </a:rPr>
              <a:t>Supplementary Table S.T5: Percentage distributions of response (grade of agreement: 1 – 5, ranging from strongly disagree to strongly agree) for Likert-Scale questions asked in the food science course, separately for those who use other digital learning media or not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  <Company>TiHo</Company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0-02-24T14:51:30Z</dcterms:created>
  <dc:creator>Liebig, Pamela</dc:creator>
  <dc:description/>
  <dc:language>en-US</dc:language>
  <cp:lastModifiedBy>Jung, Klaus</cp:lastModifiedBy>
  <dcterms:modified xsi:type="dcterms:W3CDTF">2021-07-15T13:40:58Z</dcterms:modified>
  <cp:revision>25</cp:revision>
  <dc:subject/>
  <dc:title>Supplementary Material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HiddenSlides">
    <vt:r8>0</vt:r8>
  </property>
  <property fmtid="{D5CDD505-2E9C-101B-9397-08002B2CF9AE}" pid="3" name="HyperlinksChanged">
    <vt:bool>0</vt:bool>
  </property>
  <property fmtid="{D5CDD505-2E9C-101B-9397-08002B2CF9AE}" pid="4" name="LinksUpToDate">
    <vt:bool>0</vt:bool>
  </property>
  <property fmtid="{D5CDD505-2E9C-101B-9397-08002B2CF9AE}" pid="5" name="MMClips">
    <vt:r8>0</vt:r8>
  </property>
  <property fmtid="{D5CDD505-2E9C-101B-9397-08002B2CF9AE}" pid="6" name="Notes">
    <vt:r8>0</vt:r8>
  </property>
  <property fmtid="{D5CDD505-2E9C-101B-9397-08002B2CF9AE}" pid="7" name="PresentationFormat">
    <vt:lpwstr>Breitbild</vt:lpwstr>
  </property>
  <property fmtid="{D5CDD505-2E9C-101B-9397-08002B2CF9AE}" pid="8" name="ScaleCrop">
    <vt:bool>0</vt:bool>
  </property>
  <property fmtid="{D5CDD505-2E9C-101B-9397-08002B2CF9AE}" pid="9" name="ShareDoc">
    <vt:bool>0</vt:bool>
  </property>
  <property fmtid="{D5CDD505-2E9C-101B-9397-08002B2CF9AE}" pid="10" name="Slides">
    <vt:r8>8</vt:r8>
  </property>
</Properties>
</file>